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46875" cy="98821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C1651B-1320-4AF4-9DE8-4957DCBE540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DCDA2C-0FB3-430E-826B-39EA668F62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8E7640-2F5C-4F38-8D8E-EE2732F9FD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08C358-A602-4774-9918-732DA36E86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E201A3-82BE-4FDF-8591-2409021D47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CA0534-73B7-4B36-9289-D50104FE8C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BA7BB4-9EC2-4ADC-8A18-0F6EFC348B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0913DE-627D-4FB8-8564-DF3CE32DB7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C4847A-94BA-4200-89CC-F08575445E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2988F9-51B5-46D0-924D-8FC1C93F22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88487F-BD00-4F0C-B0F2-93DF51DD78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3CD252-9D70-4697-A7AC-2D028E43E8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AA1944-D153-4DF0-AF0B-BDED87FB368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638280" y="4951440"/>
          <a:ext cx="5610240" cy="34210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38280" y="4951440"/>
                    <a:ext cx="5610240" cy="3421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896760" y="4572000"/>
          <a:ext cx="5627520" cy="669960"/>
        </p:xfrm>
        <a:graphic>
          <a:graphicData uri="http://schemas.openxmlformats.org/drawingml/2006/table">
            <a:tbl>
              <a:tblPr/>
              <a:tblGrid>
                <a:gridCol w="5627520"/>
              </a:tblGrid>
              <a:tr h="6699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40.50.300</a:t>
                      </a:r>
                      <a:r>
                        <a:rPr b="1" lang="en-US" sz="2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</a:t>
                      </a: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GB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-loop containing nucleotide triphosphate hydrolases superfamily (292 clusters)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"/>
          <p:cNvSpPr/>
          <p:nvPr/>
        </p:nvSpPr>
        <p:spPr>
          <a:xfrm>
            <a:off x="2164320" y="8024760"/>
            <a:ext cx="2487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Euclidean dist. class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0800000">
            <a:off x="378000" y="5535360"/>
            <a:ext cx="454680" cy="12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Percentag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294800" y="5276880"/>
            <a:ext cx="155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Within Famil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294080" y="5637240"/>
            <a:ext cx="165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Family vs. re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"/>
          <p:cNvGrpSpPr/>
          <p:nvPr/>
        </p:nvGrpSpPr>
        <p:grpSpPr>
          <a:xfrm>
            <a:off x="3860640" y="5715000"/>
            <a:ext cx="432000" cy="144360"/>
            <a:chOff x="3860640" y="5715000"/>
            <a:chExt cx="432000" cy="144360"/>
          </a:xfrm>
        </p:grpSpPr>
        <p:sp>
          <p:nvSpPr>
            <p:cNvPr id="49" name=""/>
            <p:cNvSpPr/>
            <p:nvPr/>
          </p:nvSpPr>
          <p:spPr>
            <a:xfrm>
              <a:off x="3860640" y="5786280"/>
              <a:ext cx="432000" cy="0"/>
            </a:xfrm>
            <a:prstGeom prst="line">
              <a:avLst/>
            </a:prstGeom>
            <a:ln w="2844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992400" y="5715000"/>
              <a:ext cx="144360" cy="144360"/>
            </a:xfrm>
            <a:prstGeom prst="diamond">
              <a:avLst/>
            </a:prstGeom>
            <a:solidFill>
              <a:srgbClr val="333399"/>
            </a:solidFill>
            <a:ln w="936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560" bIns="25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1" name=""/>
          <p:cNvSpPr/>
          <p:nvPr/>
        </p:nvSpPr>
        <p:spPr>
          <a:xfrm>
            <a:off x="3860640" y="5464080"/>
            <a:ext cx="432000" cy="0"/>
          </a:xfrm>
          <a:prstGeom prst="line">
            <a:avLst/>
          </a:prstGeom>
          <a:ln w="28440">
            <a:solidFill>
              <a:srgbClr val="fd3f0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006800" y="5415120"/>
            <a:ext cx="111240" cy="99720"/>
          </a:xfrm>
          <a:prstGeom prst="rect">
            <a:avLst/>
          </a:prstGeom>
          <a:solidFill>
            <a:srgbClr val="ef5d03"/>
          </a:solidFill>
          <a:ln w="9360">
            <a:solidFill>
              <a:srgbClr val="ef5d0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3" name=""/>
          <p:cNvGraphicFramePr/>
          <p:nvPr/>
        </p:nvGraphicFramePr>
        <p:xfrm>
          <a:off x="620640" y="326880"/>
          <a:ext cx="5721480" cy="398952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5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620640" y="326880"/>
                    <a:ext cx="5721480" cy="3989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5" name=""/>
          <p:cNvGraphicFramePr/>
          <p:nvPr/>
        </p:nvGraphicFramePr>
        <p:xfrm>
          <a:off x="1413000" y="108000"/>
          <a:ext cx="4628880" cy="576360"/>
        </p:xfrm>
        <a:graphic>
          <a:graphicData uri="http://schemas.openxmlformats.org/drawingml/2006/table">
            <a:tbl>
              <a:tblPr/>
              <a:tblGrid>
                <a:gridCol w="4628880"/>
              </a:tblGrid>
              <a:tr h="5763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logous vs. heterologous pairs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6" name=""/>
          <p:cNvSpPr/>
          <p:nvPr/>
        </p:nvSpPr>
        <p:spPr>
          <a:xfrm>
            <a:off x="2208600" y="3851280"/>
            <a:ext cx="2487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Euclidean dist. class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10800000">
            <a:off x="378000" y="1191960"/>
            <a:ext cx="454680" cy="12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Percentag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725000" y="755640"/>
            <a:ext cx="13100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Homol. pai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(6% of all pair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724280" y="1258920"/>
            <a:ext cx="1395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Heterol. pai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(94% of all pair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0" name=""/>
          <p:cNvGrpSpPr/>
          <p:nvPr/>
        </p:nvGrpSpPr>
        <p:grpSpPr>
          <a:xfrm>
            <a:off x="4292640" y="1332000"/>
            <a:ext cx="431640" cy="144360"/>
            <a:chOff x="4292640" y="1332000"/>
            <a:chExt cx="431640" cy="144360"/>
          </a:xfrm>
        </p:grpSpPr>
        <p:sp>
          <p:nvSpPr>
            <p:cNvPr id="61" name=""/>
            <p:cNvSpPr/>
            <p:nvPr/>
          </p:nvSpPr>
          <p:spPr>
            <a:xfrm>
              <a:off x="4292640" y="1403280"/>
              <a:ext cx="431640" cy="0"/>
            </a:xfrm>
            <a:prstGeom prst="line">
              <a:avLst/>
            </a:prstGeom>
            <a:ln w="2844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424040" y="1332000"/>
              <a:ext cx="144000" cy="144360"/>
            </a:xfrm>
            <a:prstGeom prst="diamond">
              <a:avLst/>
            </a:prstGeom>
            <a:solidFill>
              <a:srgbClr val="333399"/>
            </a:solidFill>
            <a:ln w="936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560" bIns="25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3" name=""/>
          <p:cNvGrpSpPr/>
          <p:nvPr/>
        </p:nvGrpSpPr>
        <p:grpSpPr>
          <a:xfrm>
            <a:off x="4280040" y="868320"/>
            <a:ext cx="431640" cy="100080"/>
            <a:chOff x="4280040" y="868320"/>
            <a:chExt cx="431640" cy="100080"/>
          </a:xfrm>
        </p:grpSpPr>
        <p:sp>
          <p:nvSpPr>
            <p:cNvPr id="64" name=""/>
            <p:cNvSpPr/>
            <p:nvPr/>
          </p:nvSpPr>
          <p:spPr>
            <a:xfrm>
              <a:off x="4280040" y="917640"/>
              <a:ext cx="431640" cy="0"/>
            </a:xfrm>
            <a:prstGeom prst="line">
              <a:avLst/>
            </a:prstGeom>
            <a:ln w="28440">
              <a:solidFill>
                <a:srgbClr val="fd3f0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438800" y="868320"/>
              <a:ext cx="110880" cy="100080"/>
            </a:xfrm>
            <a:prstGeom prst="rect">
              <a:avLst/>
            </a:prstGeom>
            <a:solidFill>
              <a:srgbClr val="ef5d03"/>
            </a:solidFill>
            <a:ln w="9360">
              <a:solidFill>
                <a:srgbClr val="ef5d0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"/>
          <p:cNvSpPr/>
          <p:nvPr/>
        </p:nvSpPr>
        <p:spPr>
          <a:xfrm>
            <a:off x="2064600" y="867564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upplementary Figure 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18T18:45:57Z</dcterms:created>
  <dc:creator>ucbcja0</dc:creator>
  <dc:description/>
  <dc:language>en-US</dc:language>
  <cp:lastModifiedBy>ucbcja0</cp:lastModifiedBy>
  <dcterms:modified xsi:type="dcterms:W3CDTF">2007-06-08T15:44:22Z</dcterms:modified>
  <cp:revision>15</cp:revision>
  <dc:subject/>
  <dc:title>Slide 1</dc:title>
</cp:coreProperties>
</file>